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27.jpeg" ContentType="image/jpeg"/>
  <Override PartName="/ppt/media/image26.jpeg" ContentType="image/jpeg"/>
  <Override PartName="/ppt/media/image23.jpeg" ContentType="image/jpeg"/>
  <Override PartName="/ppt/media/image22.png" ContentType="image/png"/>
  <Override PartName="/ppt/media/image24.jpeg" ContentType="image/jpeg"/>
  <Override PartName="/ppt/media/image21.png" ContentType="image/png"/>
  <Override PartName="/ppt/media/image19.png" ContentType="image/png"/>
  <Override PartName="/ppt/media/image7.png" ContentType="image/png"/>
  <Override PartName="/ppt/media/image34.jpeg" ContentType="image/jpeg"/>
  <Override PartName="/ppt/media/image18.png" ContentType="image/png"/>
  <Override PartName="/ppt/media/image28.jpeg" ContentType="image/jpeg"/>
  <Override PartName="/ppt/media/image8.png" ContentType="image/png"/>
  <Override PartName="/ppt/media/image14.jpeg" ContentType="image/jpeg"/>
  <Override PartName="/ppt/media/image11.jpeg" ContentType="image/jpeg"/>
  <Override PartName="/ppt/media/image9.jpeg" ContentType="image/jpeg"/>
  <Override PartName="/ppt/media/image20.png" ContentType="image/png"/>
  <Override PartName="/ppt/media/image36.jpeg" ContentType="image/jpeg"/>
  <Override PartName="/ppt/media/image29.jpeg" ContentType="image/jpeg"/>
  <Override PartName="/ppt/media/image10.jpeg" ContentType="image/jpeg"/>
  <Override PartName="/ppt/media/image5.png" ContentType="image/png"/>
  <Override PartName="/ppt/media/image35.jpeg" ContentType="image/jpeg"/>
  <Override PartName="/ppt/media/image30.jpeg" ContentType="image/jpeg"/>
  <Override PartName="/ppt/media/image15.png" ContentType="image/png"/>
  <Override PartName="/ppt/media/image31.jpeg" ContentType="image/jpeg"/>
  <Override PartName="/ppt/media/image2.png" ContentType="image/png"/>
  <Override PartName="/ppt/media/image25.jpeg" ContentType="image/jpeg"/>
  <Override PartName="/ppt/media/image33.jpeg" ContentType="image/jpeg"/>
  <Override PartName="/ppt/media/image6.png" ContentType="image/png"/>
  <Override PartName="/ppt/media/image13.jpeg" ContentType="image/jpeg"/>
  <Override PartName="/ppt/media/image12.jpeg" ContentType="image/jpeg"/>
  <Override PartName="/ppt/media/image4.png" ContentType="image/png"/>
  <Override PartName="/ppt/media/image3.png" ContentType="image/png"/>
  <Override PartName="/ppt/media/image1.png" ContentType="image/png"/>
  <Override PartName="/ppt/media/image16.png" ContentType="image/png"/>
  <Override PartName="/ppt/media/image32.jpeg" ContentType="image/jpeg"/>
  <Override PartName="/ppt/media/image17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</p:sldIdLst>
  <p:sldSz cx="13716000" cy="17373600"/>
  <p:notesSz cx="6889750" cy="1002188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90400" cy="100224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86200" cy="503280"/>
          </a:xfrm>
          <a:prstGeom prst="rect">
            <a:avLst/>
          </a:prstGeom>
          <a:noFill/>
          <a:ln w="0">
            <a:noFill/>
          </a:ln>
        </p:spPr>
        <p:txBody>
          <a:bodyPr lIns="96480" rIns="96480" tIns="48240" bIns="48240" anchor="t">
            <a:noAutofit/>
          </a:bodyPr>
          <a:p>
            <a:pPr indent="0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901680" y="0"/>
            <a:ext cx="2986200" cy="503280"/>
          </a:xfrm>
          <a:prstGeom prst="rect">
            <a:avLst/>
          </a:prstGeom>
          <a:noFill/>
          <a:ln w="0">
            <a:noFill/>
          </a:ln>
        </p:spPr>
        <p:txBody>
          <a:bodyPr lIns="96480" rIns="96480" tIns="48240" bIns="48240" anchor="t">
            <a:noAutofit/>
          </a:bodyPr>
          <a:lstStyle>
            <a:lvl1pPr indent="0" algn="r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  <a:defRPr b="0" lang="el-GR" sz="13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r>
              <a:rPr b="0" lang="el-GR" sz="13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09600" y="1252080"/>
            <a:ext cx="2670120" cy="33829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6480" rIns="96480" tIns="48240" bIns="48240" anchor="ctr">
            <a:noAutofit/>
          </a:bodyPr>
          <a:p>
            <a:pPr indent="0" algn="ctr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r>
              <a:rPr b="0" lang="en-US" sz="85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8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9040" y="4822920"/>
            <a:ext cx="5511600" cy="3946320"/>
          </a:xfrm>
          <a:prstGeom prst="rect">
            <a:avLst/>
          </a:prstGeom>
          <a:noFill/>
          <a:ln w="0">
            <a:noFill/>
          </a:ln>
        </p:spPr>
        <p:txBody>
          <a:bodyPr lIns="96480" rIns="96480" tIns="48240" bIns="4824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9518760"/>
            <a:ext cx="2986200" cy="503280"/>
          </a:xfrm>
          <a:prstGeom prst="rect">
            <a:avLst/>
          </a:prstGeom>
          <a:noFill/>
          <a:ln w="0">
            <a:noFill/>
          </a:ln>
        </p:spPr>
        <p:txBody>
          <a:bodyPr lIns="96480" rIns="96480" tIns="48240" bIns="48240" anchor="b">
            <a:noAutofit/>
          </a:bodyPr>
          <a:p>
            <a:pPr indent="0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901680" y="9518760"/>
            <a:ext cx="2986200" cy="503280"/>
          </a:xfrm>
          <a:prstGeom prst="rect">
            <a:avLst/>
          </a:prstGeom>
          <a:noFill/>
          <a:ln w="0">
            <a:noFill/>
          </a:ln>
        </p:spPr>
        <p:txBody>
          <a:bodyPr lIns="96480" rIns="96480" tIns="48240" bIns="48240" anchor="b">
            <a:noAutofit/>
          </a:bodyPr>
          <a:lstStyle>
            <a:lvl1pPr indent="0" algn="r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  <a:defRPr b="0" lang="el-GR" sz="13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fld id="{A9D1277C-5A1C-42BF-9D4C-98A48D378264}" type="slidenum">
              <a:rPr b="0" lang="el-GR" sz="13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8" name="PlaceHolder 1"/>
          <p:cNvSpPr>
            <a:spLocks noGrp="1"/>
          </p:cNvSpPr>
          <p:nvPr>
            <p:ph type="sldImg"/>
          </p:nvPr>
        </p:nvSpPr>
        <p:spPr>
          <a:xfrm>
            <a:off x="2109960" y="1252440"/>
            <a:ext cx="2670120" cy="3382920"/>
          </a:xfrm>
          <a:prstGeom prst="rect">
            <a:avLst/>
          </a:prstGeom>
          <a:ln w="0">
            <a:noFill/>
          </a:ln>
        </p:spPr>
      </p:sp>
      <p:sp>
        <p:nvSpPr>
          <p:cNvPr id="119" name="PlaceHolder 2"/>
          <p:cNvSpPr>
            <a:spLocks noGrp="1"/>
          </p:cNvSpPr>
          <p:nvPr>
            <p:ph type="body"/>
          </p:nvPr>
        </p:nvSpPr>
        <p:spPr>
          <a:xfrm>
            <a:off x="689040" y="4822920"/>
            <a:ext cx="5511600" cy="3946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0" name="Θέση αριθμού διαφάνειας 3"/>
          <p:cNvSpPr/>
          <p:nvPr/>
        </p:nvSpPr>
        <p:spPr>
          <a:xfrm>
            <a:off x="3902040" y="9518760"/>
            <a:ext cx="2986200" cy="503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6480" rIns="96480" tIns="48240" bIns="48240" anchor="b">
            <a:noAutofit/>
          </a:bodyPr>
          <a:p>
            <a:pPr algn="r"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fld id="{0D7E883C-82B9-402E-A662-117B458E9A59}" type="slidenum">
              <a:rPr b="0" lang="el-GR" sz="13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A35050-3EA2-4FCB-B061-F68FDE6A068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95160"/>
            <a:ext cx="12344400" cy="289584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ctr">
            <a:noAutofit/>
          </a:bodyPr>
          <a:p>
            <a:pPr indent="0" algn="ctr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8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4053960"/>
            <a:ext cx="1234440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10042200"/>
            <a:ext cx="1234440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42B2B3-C729-4E81-B307-1858854BA8E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95160"/>
            <a:ext cx="12344400" cy="289584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ctr">
            <a:noAutofit/>
          </a:bodyPr>
          <a:p>
            <a:pPr indent="0" algn="ctr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8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4053960"/>
            <a:ext cx="602388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7011360" y="4053960"/>
            <a:ext cx="602388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10042200"/>
            <a:ext cx="602388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7011360" y="10042200"/>
            <a:ext cx="602388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502165-658D-4F9A-A85F-A0AA4221D1F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95160"/>
            <a:ext cx="12344400" cy="289584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ctr">
            <a:noAutofit/>
          </a:bodyPr>
          <a:p>
            <a:pPr indent="0" algn="ctr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8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4053960"/>
            <a:ext cx="397476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859640" y="4053960"/>
            <a:ext cx="397476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9033480" y="4053960"/>
            <a:ext cx="397476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10042200"/>
            <a:ext cx="397476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859640" y="10042200"/>
            <a:ext cx="397476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9033480" y="10042200"/>
            <a:ext cx="397476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0D432A-F0A3-4A10-90A1-CF7B7912EFE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95160"/>
            <a:ext cx="12344400" cy="289584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ctr">
            <a:noAutofit/>
          </a:bodyPr>
          <a:p>
            <a:pPr indent="0" algn="ctr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8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4053960"/>
            <a:ext cx="12344400" cy="11464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1551"/>
              </a:spcBef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898D4A-2F87-48EC-8030-C09B124D801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95160"/>
            <a:ext cx="12344400" cy="289584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ctr">
            <a:noAutofit/>
          </a:bodyPr>
          <a:p>
            <a:pPr indent="0" algn="ctr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8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4053960"/>
            <a:ext cx="12344400" cy="1146492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77904A-0D83-4B71-B781-6DC6D2E7038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95160"/>
            <a:ext cx="12344400" cy="289584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ctr">
            <a:noAutofit/>
          </a:bodyPr>
          <a:p>
            <a:pPr indent="0" algn="ctr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8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4053960"/>
            <a:ext cx="6023880" cy="1146492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7011360" y="4053960"/>
            <a:ext cx="6023880" cy="1146492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3E9D5F-04EA-49A9-BDDD-F5C9688FA5D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95160"/>
            <a:ext cx="12344400" cy="289584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ctr">
            <a:noAutofit/>
          </a:bodyPr>
          <a:p>
            <a:pPr indent="0" algn="ctr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8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6038A0-89CB-4C95-95CA-1B3A4623B78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95160"/>
            <a:ext cx="12344400" cy="13424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1551"/>
              </a:spcBef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6BE8E5-BDA1-496F-A410-8186B6CB649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95160"/>
            <a:ext cx="12344400" cy="289584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ctr">
            <a:noAutofit/>
          </a:bodyPr>
          <a:p>
            <a:pPr indent="0" algn="ctr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8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4053960"/>
            <a:ext cx="602388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7011360" y="4053960"/>
            <a:ext cx="6023880" cy="1146492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10042200"/>
            <a:ext cx="602388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A78249-46DA-4BEE-A349-5743BDCB9F8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95160"/>
            <a:ext cx="12344400" cy="289584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ctr">
            <a:noAutofit/>
          </a:bodyPr>
          <a:p>
            <a:pPr indent="0" algn="ctr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8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4053960"/>
            <a:ext cx="6023880" cy="1146492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7011360" y="4053960"/>
            <a:ext cx="602388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7011360" y="10042200"/>
            <a:ext cx="602388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D373EF-770E-450E-B4F3-1BA78186E11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95160"/>
            <a:ext cx="12344400" cy="289584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ctr">
            <a:noAutofit/>
          </a:bodyPr>
          <a:p>
            <a:pPr indent="0" algn="ctr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8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4053960"/>
            <a:ext cx="602388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7011360" y="4053960"/>
            <a:ext cx="602388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10042200"/>
            <a:ext cx="1234440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F35662-E6B1-4BB0-8FA7-956E3D16BED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95160"/>
            <a:ext cx="12344400" cy="289584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ctr">
            <a:noAutofit/>
          </a:bodyPr>
          <a:p>
            <a:pPr indent="0" algn="ctr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r>
              <a:rPr b="0" lang="en-US" sz="85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8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4053960"/>
            <a:ext cx="12344400" cy="1146492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marL="665280" indent="-665280">
              <a:spcBef>
                <a:spcPts val="1551"/>
              </a:spcBef>
              <a:buClr>
                <a:srgbClr val="000000"/>
              </a:buClr>
              <a:buFont typeface="Arial"/>
              <a:buChar char="•"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r>
              <a:rPr b="0" lang="en-US" sz="6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  <a:p>
            <a:pPr lvl="1" marL="1442880" indent="-554040">
              <a:spcBef>
                <a:spcPts val="1551"/>
              </a:spcBef>
              <a:buClr>
                <a:srgbClr val="000000"/>
              </a:buClr>
              <a:buFont typeface="Arial"/>
              <a:buChar char="–"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r>
              <a:rPr b="0" lang="en-US" sz="6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  <a:p>
            <a:pPr lvl="2" marL="2219400" indent="-443160">
              <a:spcBef>
                <a:spcPts val="1551"/>
              </a:spcBef>
              <a:buClr>
                <a:srgbClr val="000000"/>
              </a:buClr>
              <a:buFont typeface="Arial"/>
              <a:buChar char="•"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r>
              <a:rPr b="0" lang="en-US" sz="6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  <a:p>
            <a:pPr lvl="3" marL="3108240" indent="-442800">
              <a:spcBef>
                <a:spcPts val="1551"/>
              </a:spcBef>
              <a:buClr>
                <a:srgbClr val="000000"/>
              </a:buClr>
              <a:buFont typeface="Arial"/>
              <a:buChar char="–"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r>
              <a:rPr b="0" lang="en-US" sz="6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  <a:p>
            <a:pPr lvl="4" marL="3995640" indent="-442800">
              <a:spcBef>
                <a:spcPts val="1551"/>
              </a:spcBef>
              <a:buClr>
                <a:srgbClr val="000000"/>
              </a:buClr>
              <a:buFont typeface="Arial"/>
              <a:buChar char="»"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r>
              <a:rPr b="0" lang="en-US" sz="6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  <a:p>
            <a:pPr lvl="5" marL="3995640" indent="-442800">
              <a:spcBef>
                <a:spcPts val="1551"/>
              </a:spcBef>
              <a:buClr>
                <a:srgbClr val="000000"/>
              </a:buClr>
              <a:buFont typeface="Arial"/>
              <a:buChar char="»"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r>
              <a:rPr b="0" lang="en-US" sz="6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  <a:p>
            <a:pPr lvl="6" marL="3995640" indent="-442800">
              <a:spcBef>
                <a:spcPts val="1551"/>
              </a:spcBef>
              <a:buClr>
                <a:srgbClr val="000000"/>
              </a:buClr>
              <a:buFont typeface="Arial"/>
              <a:buChar char="»"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r>
              <a:rPr b="0" lang="en-US" sz="6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16101720"/>
            <a:ext cx="3200400" cy="92556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  <a:defRPr b="0" lang="en-US" sz="23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r>
              <a:rPr b="0" lang="en-US" sz="23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2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686120" y="16101720"/>
            <a:ext cx="4343400" cy="92556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ctr">
            <a:noAutofit/>
          </a:bodyPr>
          <a:p>
            <a:pPr indent="0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9829800" y="16101720"/>
            <a:ext cx="3200400" cy="92556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  <a:defRPr b="0" lang="en-US" sz="23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fld id="{9AC63E17-9506-42F1-824C-E3E805FB0CED}" type="slidenum">
              <a:rPr b="0" lang="en-US" sz="23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23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jpeg"/><Relationship Id="rId10" Type="http://schemas.openxmlformats.org/officeDocument/2006/relationships/image" Target="../media/image10.jpeg"/><Relationship Id="rId11" Type="http://schemas.openxmlformats.org/officeDocument/2006/relationships/image" Target="../media/image11.jpeg"/><Relationship Id="rId12" Type="http://schemas.openxmlformats.org/officeDocument/2006/relationships/image" Target="../media/image12.jpeg"/><Relationship Id="rId13" Type="http://schemas.openxmlformats.org/officeDocument/2006/relationships/image" Target="../media/image13.jpeg"/><Relationship Id="rId14" Type="http://schemas.openxmlformats.org/officeDocument/2006/relationships/image" Target="../media/image14.jpeg"/><Relationship Id="rId15" Type="http://schemas.openxmlformats.org/officeDocument/2006/relationships/image" Target="../media/image15.png"/><Relationship Id="rId16" Type="http://schemas.openxmlformats.org/officeDocument/2006/relationships/image" Target="../media/image16.png"/><Relationship Id="rId17" Type="http://schemas.openxmlformats.org/officeDocument/2006/relationships/image" Target="../media/image17.png"/><Relationship Id="rId18" Type="http://schemas.openxmlformats.org/officeDocument/2006/relationships/image" Target="../media/image18.png"/><Relationship Id="rId19" Type="http://schemas.openxmlformats.org/officeDocument/2006/relationships/image" Target="../media/image19.png"/><Relationship Id="rId20" Type="http://schemas.openxmlformats.org/officeDocument/2006/relationships/image" Target="../media/image20.png"/><Relationship Id="rId21" Type="http://schemas.openxmlformats.org/officeDocument/2006/relationships/image" Target="../media/image21.png"/><Relationship Id="rId22" Type="http://schemas.openxmlformats.org/officeDocument/2006/relationships/image" Target="../media/image22.png"/><Relationship Id="rId23" Type="http://schemas.openxmlformats.org/officeDocument/2006/relationships/image" Target="../media/image23.jpeg"/><Relationship Id="rId24" Type="http://schemas.openxmlformats.org/officeDocument/2006/relationships/image" Target="../media/image24.jpeg"/><Relationship Id="rId25" Type="http://schemas.openxmlformats.org/officeDocument/2006/relationships/slideLayout" Target="../slideLayouts/slideLayout1.xml"/><Relationship Id="rId26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5.jpeg"/><Relationship Id="rId2" Type="http://schemas.openxmlformats.org/officeDocument/2006/relationships/image" Target="../media/image26.jpeg"/><Relationship Id="rId3" Type="http://schemas.openxmlformats.org/officeDocument/2006/relationships/image" Target="../media/image27.jpeg"/><Relationship Id="rId4" Type="http://schemas.openxmlformats.org/officeDocument/2006/relationships/image" Target="../media/image28.jpeg"/><Relationship Id="rId5" Type="http://schemas.openxmlformats.org/officeDocument/2006/relationships/image" Target="../media/image29.jpeg"/><Relationship Id="rId6" Type="http://schemas.openxmlformats.org/officeDocument/2006/relationships/image" Target="../media/image30.jpeg"/><Relationship Id="rId7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1.jpeg"/><Relationship Id="rId2" Type="http://schemas.openxmlformats.org/officeDocument/2006/relationships/image" Target="../media/image32.jpeg"/><Relationship Id="rId3" Type="http://schemas.openxmlformats.org/officeDocument/2006/relationships/image" Target="../media/image33.jpeg"/><Relationship Id="rId4" Type="http://schemas.openxmlformats.org/officeDocument/2006/relationships/image" Target="../media/image34.jpeg"/><Relationship Id="rId5" Type="http://schemas.openxmlformats.org/officeDocument/2006/relationships/image" Target="../media/image35.jpeg"/><Relationship Id="rId6" Type="http://schemas.openxmlformats.org/officeDocument/2006/relationships/image" Target="../media/image36.jpeg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42 - TextBox"/>
          <p:cNvSpPr/>
          <p:nvPr/>
        </p:nvSpPr>
        <p:spPr>
          <a:xfrm>
            <a:off x="363600" y="1647720"/>
            <a:ext cx="733320" cy="396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42 - TextBox"/>
          <p:cNvSpPr/>
          <p:nvPr/>
        </p:nvSpPr>
        <p:spPr>
          <a:xfrm>
            <a:off x="352440" y="10663200"/>
            <a:ext cx="733320" cy="396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Rectangle 29"/>
          <p:cNvSpPr/>
          <p:nvPr/>
        </p:nvSpPr>
        <p:spPr>
          <a:xfrm>
            <a:off x="109440" y="33480"/>
            <a:ext cx="681984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Times New Roman"/>
                <a:ea typeface="Calibri"/>
              </a:rPr>
              <a:t>Additional file 5: Figure  S5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42 - TextBox"/>
          <p:cNvSpPr/>
          <p:nvPr/>
        </p:nvSpPr>
        <p:spPr>
          <a:xfrm>
            <a:off x="355680" y="5878440"/>
            <a:ext cx="733320" cy="396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2" name="Ομάδα 33881"/>
          <p:cNvGrpSpPr/>
          <p:nvPr/>
        </p:nvGrpSpPr>
        <p:grpSpPr>
          <a:xfrm>
            <a:off x="1103400" y="6238800"/>
            <a:ext cx="11814120" cy="3757680"/>
            <a:chOff x="1103400" y="6238800"/>
            <a:chExt cx="11814120" cy="3757680"/>
          </a:xfrm>
        </p:grpSpPr>
        <p:sp>
          <p:nvSpPr>
            <p:cNvPr id="53" name="TextBox 4"/>
            <p:cNvSpPr/>
            <p:nvPr/>
          </p:nvSpPr>
          <p:spPr>
            <a:xfrm>
              <a:off x="2305080" y="6238800"/>
              <a:ext cx="18921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776240"/>
                  <a:tab algn="l" pos="3552840"/>
                  <a:tab algn="l" pos="5329080"/>
                  <a:tab algn="l" pos="7105680"/>
                  <a:tab algn="l" pos="8881920"/>
                  <a:tab algn="l" pos="1065852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CF</a:t>
              </a:r>
              <a:r>
                <a:rPr b="0" lang="el-GR" sz="1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10Α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84 - TextBox"/>
            <p:cNvSpPr/>
            <p:nvPr/>
          </p:nvSpPr>
          <p:spPr>
            <a:xfrm>
              <a:off x="2998800" y="6662520"/>
              <a:ext cx="1814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1776240"/>
                  <a:tab algn="l" pos="3552840"/>
                  <a:tab algn="l" pos="5329080"/>
                  <a:tab algn="l" pos="7105680"/>
                  <a:tab algn="l" pos="8881920"/>
                  <a:tab algn="l" pos="1065852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ERGE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108 - TextBox"/>
            <p:cNvSpPr/>
            <p:nvPr/>
          </p:nvSpPr>
          <p:spPr>
            <a:xfrm>
              <a:off x="1619280" y="6667200"/>
              <a:ext cx="1563480" cy="27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5160" rIns="65160" tIns="32760" bIns="3276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1776240"/>
                  <a:tab algn="l" pos="3552840"/>
                  <a:tab algn="l" pos="5329080"/>
                  <a:tab algn="l" pos="7105680"/>
                  <a:tab algn="l" pos="8881920"/>
                  <a:tab algn="l" pos="10658520"/>
                </a:tabLst>
              </a:pPr>
              <a:r>
                <a:rPr b="1" lang="el-GR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γΗ2ΑΧ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108 - TextBox"/>
            <p:cNvSpPr/>
            <p:nvPr/>
          </p:nvSpPr>
          <p:spPr>
            <a:xfrm rot="16200000">
              <a:off x="532800" y="7469280"/>
              <a:ext cx="1395000" cy="253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39960" rIns="39960" tIns="20160" bIns="2016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1776240"/>
                  <a:tab algn="l" pos="3552840"/>
                  <a:tab algn="l" pos="5329080"/>
                  <a:tab algn="l" pos="7105680"/>
                  <a:tab algn="l" pos="8881920"/>
                  <a:tab algn="l" pos="1065852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CRAMBLE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108 - TextBox"/>
            <p:cNvSpPr/>
            <p:nvPr/>
          </p:nvSpPr>
          <p:spPr>
            <a:xfrm rot="16200000">
              <a:off x="546840" y="8988120"/>
              <a:ext cx="1395000" cy="253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39960" rIns="39960" tIns="20160" bIns="2016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1776240"/>
                  <a:tab algn="l" pos="3552840"/>
                  <a:tab algn="l" pos="5329080"/>
                  <a:tab algn="l" pos="7105680"/>
                  <a:tab algn="l" pos="8881920"/>
                  <a:tab algn="l" pos="1065852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TPA ARNAi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76 - Ευθεία γραμμή σύνδεσης"/>
            <p:cNvSpPr/>
            <p:nvPr/>
          </p:nvSpPr>
          <p:spPr>
            <a:xfrm>
              <a:off x="1542960" y="6622920"/>
              <a:ext cx="32400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TextBox 4"/>
            <p:cNvSpPr/>
            <p:nvPr/>
          </p:nvSpPr>
          <p:spPr>
            <a:xfrm>
              <a:off x="5624280" y="6238800"/>
              <a:ext cx="22143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776240"/>
                  <a:tab algn="l" pos="3552840"/>
                  <a:tab algn="l" pos="5329080"/>
                  <a:tab algn="l" pos="7105680"/>
                  <a:tab algn="l" pos="8881920"/>
                  <a:tab algn="l" pos="1065852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DA-MB-231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84 - TextBox"/>
            <p:cNvSpPr/>
            <p:nvPr/>
          </p:nvSpPr>
          <p:spPr>
            <a:xfrm>
              <a:off x="6413400" y="6648120"/>
              <a:ext cx="18176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1776240"/>
                  <a:tab algn="l" pos="3552840"/>
                  <a:tab algn="l" pos="5329080"/>
                  <a:tab algn="l" pos="7105680"/>
                  <a:tab algn="l" pos="8881920"/>
                  <a:tab algn="l" pos="1065852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ERGE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108 - TextBox"/>
            <p:cNvSpPr/>
            <p:nvPr/>
          </p:nvSpPr>
          <p:spPr>
            <a:xfrm>
              <a:off x="4962240" y="6673680"/>
              <a:ext cx="1563480" cy="27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5160" rIns="65160" tIns="32760" bIns="3276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1776240"/>
                  <a:tab algn="l" pos="3552840"/>
                  <a:tab algn="l" pos="5329080"/>
                  <a:tab algn="l" pos="7105680"/>
                  <a:tab algn="l" pos="8881920"/>
                  <a:tab algn="l" pos="10658520"/>
                </a:tabLst>
              </a:pPr>
              <a:r>
                <a:rPr b="1" lang="el-GR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γΗ2ΑΧ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76 - Ευθεία γραμμή σύνδεσης"/>
            <p:cNvSpPr/>
            <p:nvPr/>
          </p:nvSpPr>
          <p:spPr>
            <a:xfrm>
              <a:off x="4997520" y="6622920"/>
              <a:ext cx="32400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63" name="Picture 12" descr="Blue lights in the dark&#10;&#10;Description automatically generated with low confidence"/>
            <p:cNvPicPr/>
            <p:nvPr/>
          </p:nvPicPr>
          <p:blipFill>
            <a:blip r:embed="rId1"/>
            <a:stretch/>
          </p:blipFill>
          <p:spPr>
            <a:xfrm>
              <a:off x="3166920" y="6990840"/>
              <a:ext cx="1606320" cy="12459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4" name="Picture 14" descr="A picture containing night sky&#10;&#10;Description automatically generated"/>
            <p:cNvPicPr/>
            <p:nvPr/>
          </p:nvPicPr>
          <p:blipFill>
            <a:blip r:embed="rId2"/>
            <a:stretch/>
          </p:blipFill>
          <p:spPr>
            <a:xfrm>
              <a:off x="1508040" y="6990840"/>
              <a:ext cx="1604880" cy="12459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5" name="Picture 22" descr=""/>
            <p:cNvPicPr/>
            <p:nvPr/>
          </p:nvPicPr>
          <p:blipFill>
            <a:blip r:embed="rId3"/>
            <a:stretch/>
          </p:blipFill>
          <p:spPr>
            <a:xfrm>
              <a:off x="3155760" y="8417880"/>
              <a:ext cx="1604880" cy="12459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6" name="Picture 24" descr="A picture containing night sky&#10;&#10;Description automatically generated"/>
            <p:cNvPicPr/>
            <p:nvPr/>
          </p:nvPicPr>
          <p:blipFill>
            <a:blip r:embed="rId4"/>
            <a:stretch/>
          </p:blipFill>
          <p:spPr>
            <a:xfrm>
              <a:off x="1511280" y="8417880"/>
              <a:ext cx="1604880" cy="12459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7" name="Picture 26" descr="A picture containing night sky&#10;&#10;Description automatically generated"/>
            <p:cNvPicPr/>
            <p:nvPr/>
          </p:nvPicPr>
          <p:blipFill>
            <a:blip r:embed="rId5"/>
            <a:stretch/>
          </p:blipFill>
          <p:spPr>
            <a:xfrm>
              <a:off x="4976640" y="6990840"/>
              <a:ext cx="1606320" cy="12459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8" name="Picture 28" descr="A picture containing night sky&#10;&#10;Description automatically generated"/>
            <p:cNvPicPr/>
            <p:nvPr/>
          </p:nvPicPr>
          <p:blipFill>
            <a:blip r:embed="rId6"/>
            <a:stretch/>
          </p:blipFill>
          <p:spPr>
            <a:xfrm>
              <a:off x="6634080" y="6990840"/>
              <a:ext cx="1606320" cy="12459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9" name="Picture 36" descr="A picture containing night sky&#10;&#10;Description automatically generated"/>
            <p:cNvPicPr/>
            <p:nvPr/>
          </p:nvPicPr>
          <p:blipFill>
            <a:blip r:embed="rId7"/>
            <a:stretch/>
          </p:blipFill>
          <p:spPr>
            <a:xfrm>
              <a:off x="4976640" y="8417880"/>
              <a:ext cx="1606320" cy="12459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0" name="Picture 38" descr=""/>
            <p:cNvPicPr/>
            <p:nvPr/>
          </p:nvPicPr>
          <p:blipFill>
            <a:blip r:embed="rId8"/>
            <a:stretch/>
          </p:blipFill>
          <p:spPr>
            <a:xfrm>
              <a:off x="6634080" y="8417880"/>
              <a:ext cx="1606320" cy="12459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1" name="62 - Ευθεία γραμμή σύνδεσης"/>
            <p:cNvSpPr/>
            <p:nvPr/>
          </p:nvSpPr>
          <p:spPr>
            <a:xfrm>
              <a:off x="7791480" y="9784080"/>
              <a:ext cx="3013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72" name="Εικόνα 10" descr=""/>
            <p:cNvPicPr/>
            <p:nvPr/>
          </p:nvPicPr>
          <p:blipFill>
            <a:blip r:embed="rId9"/>
            <a:stretch/>
          </p:blipFill>
          <p:spPr>
            <a:xfrm>
              <a:off x="8799840" y="6312600"/>
              <a:ext cx="1856160" cy="3662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3" name="Εικόνα 15" descr=""/>
            <p:cNvPicPr/>
            <p:nvPr/>
          </p:nvPicPr>
          <p:blipFill>
            <a:blip r:embed="rId10"/>
            <a:stretch/>
          </p:blipFill>
          <p:spPr>
            <a:xfrm>
              <a:off x="11048760" y="6312600"/>
              <a:ext cx="1868760" cy="368388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74" name="Ομάδα 33865"/>
          <p:cNvGrpSpPr/>
          <p:nvPr/>
        </p:nvGrpSpPr>
        <p:grpSpPr>
          <a:xfrm>
            <a:off x="2033640" y="1947960"/>
            <a:ext cx="9937800" cy="3825720"/>
            <a:chOff x="2033640" y="1947960"/>
            <a:chExt cx="9937800" cy="3825720"/>
          </a:xfrm>
        </p:grpSpPr>
        <p:pic>
          <p:nvPicPr>
            <p:cNvPr id="75" name="Εικόνα 4" descr=""/>
            <p:cNvPicPr/>
            <p:nvPr/>
          </p:nvPicPr>
          <p:blipFill>
            <a:blip r:embed="rId11"/>
            <a:stretch/>
          </p:blipFill>
          <p:spPr>
            <a:xfrm>
              <a:off x="2033640" y="2085840"/>
              <a:ext cx="1792440" cy="36878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6" name="Εικόνα 10" descr=""/>
            <p:cNvPicPr/>
            <p:nvPr/>
          </p:nvPicPr>
          <p:blipFill>
            <a:blip r:embed="rId12"/>
            <a:stretch/>
          </p:blipFill>
          <p:spPr>
            <a:xfrm>
              <a:off x="7611120" y="1977480"/>
              <a:ext cx="1792440" cy="37663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7" name="Εικόνα 13" descr=""/>
            <p:cNvPicPr/>
            <p:nvPr/>
          </p:nvPicPr>
          <p:blipFill>
            <a:blip r:embed="rId13"/>
            <a:stretch/>
          </p:blipFill>
          <p:spPr>
            <a:xfrm>
              <a:off x="4405680" y="2009160"/>
              <a:ext cx="1853640" cy="3762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8" name="Εικόνα 15" descr=""/>
            <p:cNvPicPr/>
            <p:nvPr/>
          </p:nvPicPr>
          <p:blipFill>
            <a:blip r:embed="rId14"/>
            <a:stretch/>
          </p:blipFill>
          <p:spPr>
            <a:xfrm>
              <a:off x="10144080" y="1947960"/>
              <a:ext cx="1827360" cy="377064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79" name="Ομάδα 33882"/>
          <p:cNvGrpSpPr/>
          <p:nvPr/>
        </p:nvGrpSpPr>
        <p:grpSpPr>
          <a:xfrm>
            <a:off x="944640" y="11044080"/>
            <a:ext cx="12291840" cy="4195800"/>
            <a:chOff x="944640" y="11044080"/>
            <a:chExt cx="12291840" cy="4195800"/>
          </a:xfrm>
        </p:grpSpPr>
        <p:sp>
          <p:nvSpPr>
            <p:cNvPr id="80" name="TextBox 4"/>
            <p:cNvSpPr/>
            <p:nvPr/>
          </p:nvSpPr>
          <p:spPr>
            <a:xfrm>
              <a:off x="2287440" y="11044080"/>
              <a:ext cx="18903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776240"/>
                  <a:tab algn="l" pos="3552840"/>
                  <a:tab algn="l" pos="5329080"/>
                  <a:tab algn="l" pos="7105680"/>
                  <a:tab algn="l" pos="8881920"/>
                  <a:tab algn="l" pos="1065852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CF</a:t>
              </a:r>
              <a:r>
                <a:rPr b="0" lang="el-GR" sz="1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10Α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84 - TextBox"/>
            <p:cNvSpPr/>
            <p:nvPr/>
          </p:nvSpPr>
          <p:spPr>
            <a:xfrm>
              <a:off x="2981160" y="11477160"/>
              <a:ext cx="18140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1776240"/>
                  <a:tab algn="l" pos="3552840"/>
                  <a:tab algn="l" pos="5329080"/>
                  <a:tab algn="l" pos="7105680"/>
                  <a:tab algn="l" pos="8881920"/>
                  <a:tab algn="l" pos="1065852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ERGE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108 - TextBox"/>
            <p:cNvSpPr/>
            <p:nvPr/>
          </p:nvSpPr>
          <p:spPr>
            <a:xfrm>
              <a:off x="1600200" y="11480400"/>
              <a:ext cx="1564920" cy="27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5160" rIns="65160" tIns="32760" bIns="3276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1776240"/>
                  <a:tab algn="l" pos="3552840"/>
                  <a:tab algn="l" pos="5329080"/>
                  <a:tab algn="l" pos="7105680"/>
                  <a:tab algn="l" pos="8881920"/>
                  <a:tab algn="l" pos="10658520"/>
                </a:tabLst>
              </a:pPr>
              <a:r>
                <a:rPr b="1" lang="el-GR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γΗ2ΑΧ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108 - TextBox"/>
            <p:cNvSpPr/>
            <p:nvPr/>
          </p:nvSpPr>
          <p:spPr>
            <a:xfrm rot="16200000">
              <a:off x="492120" y="12177000"/>
              <a:ext cx="1396800" cy="46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39960" rIns="39960" tIns="20160" bIns="2016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1776240"/>
                  <a:tab algn="l" pos="3552840"/>
                  <a:tab algn="l" pos="5329080"/>
                  <a:tab algn="l" pos="7105680"/>
                  <a:tab algn="l" pos="8881920"/>
                  <a:tab algn="l" pos="1065852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CRAMBLE STS + DXR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108 - TextBox"/>
            <p:cNvSpPr/>
            <p:nvPr/>
          </p:nvSpPr>
          <p:spPr>
            <a:xfrm rot="16200000">
              <a:off x="480240" y="13697280"/>
              <a:ext cx="1395360" cy="46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39960" rIns="39960" tIns="20160" bIns="2016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1776240"/>
                  <a:tab algn="l" pos="3552840"/>
                  <a:tab algn="l" pos="5329080"/>
                  <a:tab algn="l" pos="7105680"/>
                  <a:tab algn="l" pos="8881920"/>
                  <a:tab algn="l" pos="1065852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FOXO1 RNAi  STS + DXR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76 - Ευθεία γραμμή σύνδεσης"/>
            <p:cNvSpPr/>
            <p:nvPr/>
          </p:nvSpPr>
          <p:spPr>
            <a:xfrm>
              <a:off x="1487520" y="11428200"/>
              <a:ext cx="32400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TextBox 4"/>
            <p:cNvSpPr/>
            <p:nvPr/>
          </p:nvSpPr>
          <p:spPr>
            <a:xfrm>
              <a:off x="5605200" y="11044080"/>
              <a:ext cx="22158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776240"/>
                  <a:tab algn="l" pos="3552840"/>
                  <a:tab algn="l" pos="5329080"/>
                  <a:tab algn="l" pos="7105680"/>
                  <a:tab algn="l" pos="8881920"/>
                  <a:tab algn="l" pos="1065852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DA-MB-231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84 - TextBox"/>
            <p:cNvSpPr/>
            <p:nvPr/>
          </p:nvSpPr>
          <p:spPr>
            <a:xfrm>
              <a:off x="6395760" y="11463120"/>
              <a:ext cx="18158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1776240"/>
                  <a:tab algn="l" pos="3552840"/>
                  <a:tab algn="l" pos="5329080"/>
                  <a:tab algn="l" pos="7105680"/>
                  <a:tab algn="l" pos="8881920"/>
                  <a:tab algn="l" pos="1065852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ERGE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108 - TextBox"/>
            <p:cNvSpPr/>
            <p:nvPr/>
          </p:nvSpPr>
          <p:spPr>
            <a:xfrm>
              <a:off x="4943160" y="11488320"/>
              <a:ext cx="1563480" cy="27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5160" rIns="65160" tIns="32760" bIns="3276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1776240"/>
                  <a:tab algn="l" pos="3552840"/>
                  <a:tab algn="l" pos="5329080"/>
                  <a:tab algn="l" pos="7105680"/>
                  <a:tab algn="l" pos="8881920"/>
                  <a:tab algn="l" pos="10658520"/>
                </a:tabLst>
              </a:pPr>
              <a:r>
                <a:rPr b="1" lang="el-GR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γΗ2ΑΧ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76 - Ευθεία γραμμή σύνδεσης"/>
            <p:cNvSpPr/>
            <p:nvPr/>
          </p:nvSpPr>
          <p:spPr>
            <a:xfrm>
              <a:off x="4978440" y="11428200"/>
              <a:ext cx="32032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90" name="Picture 27" descr="A picture containing night sky&#10;&#10;Description automatically generated"/>
            <p:cNvPicPr/>
            <p:nvPr/>
          </p:nvPicPr>
          <p:blipFill>
            <a:blip r:embed="rId15"/>
            <a:stretch/>
          </p:blipFill>
          <p:spPr>
            <a:xfrm>
              <a:off x="3149280" y="11812320"/>
              <a:ext cx="1604520" cy="1244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1" name="Picture 29" descr="A picture containing night sky&#10;&#10;Description automatically generated"/>
            <p:cNvPicPr/>
            <p:nvPr/>
          </p:nvPicPr>
          <p:blipFill>
            <a:blip r:embed="rId16"/>
            <a:stretch/>
          </p:blipFill>
          <p:spPr>
            <a:xfrm>
              <a:off x="1488960" y="11812320"/>
              <a:ext cx="1606320" cy="1244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2" name="Picture 41" descr="A picture containing night sky&#10;&#10;Description automatically generated"/>
            <p:cNvPicPr/>
            <p:nvPr/>
          </p:nvPicPr>
          <p:blipFill>
            <a:blip r:embed="rId17"/>
            <a:stretch/>
          </p:blipFill>
          <p:spPr>
            <a:xfrm>
              <a:off x="1488960" y="13263480"/>
              <a:ext cx="1606320" cy="1244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3" name="Picture 43" descr="A picture containing night sky&#10;&#10;Description automatically generated"/>
            <p:cNvPicPr/>
            <p:nvPr/>
          </p:nvPicPr>
          <p:blipFill>
            <a:blip r:embed="rId18"/>
            <a:stretch/>
          </p:blipFill>
          <p:spPr>
            <a:xfrm>
              <a:off x="3149280" y="13263480"/>
              <a:ext cx="1604520" cy="1244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4" name="Picture 45" descr="A picture containing dark, night sky&#10;&#10;Description automatically generated"/>
            <p:cNvPicPr/>
            <p:nvPr/>
          </p:nvPicPr>
          <p:blipFill>
            <a:blip r:embed="rId19"/>
            <a:stretch/>
          </p:blipFill>
          <p:spPr>
            <a:xfrm>
              <a:off x="4959000" y="11805840"/>
              <a:ext cx="1604520" cy="1244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5" name="Picture 47" descr=""/>
            <p:cNvPicPr/>
            <p:nvPr/>
          </p:nvPicPr>
          <p:blipFill>
            <a:blip r:embed="rId20"/>
            <a:stretch/>
          </p:blipFill>
          <p:spPr>
            <a:xfrm>
              <a:off x="6616080" y="11805840"/>
              <a:ext cx="1604520" cy="1244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6" name="Picture 49" descr="A picture containing blur&#10;&#10;Description automatically generated"/>
            <p:cNvPicPr/>
            <p:nvPr/>
          </p:nvPicPr>
          <p:blipFill>
            <a:blip r:embed="rId21"/>
            <a:stretch/>
          </p:blipFill>
          <p:spPr>
            <a:xfrm>
              <a:off x="6616080" y="13263480"/>
              <a:ext cx="1604520" cy="1244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7" name="Picture 51" descr="A picture containing night sky&#10;&#10;Description automatically generated"/>
            <p:cNvPicPr/>
            <p:nvPr/>
          </p:nvPicPr>
          <p:blipFill>
            <a:blip r:embed="rId22"/>
            <a:stretch/>
          </p:blipFill>
          <p:spPr>
            <a:xfrm>
              <a:off x="4959000" y="13263480"/>
              <a:ext cx="1604520" cy="12445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8" name="62 - Ευθεία γραμμή σύνδεσης"/>
            <p:cNvSpPr/>
            <p:nvPr/>
          </p:nvSpPr>
          <p:spPr>
            <a:xfrm>
              <a:off x="7821720" y="14592240"/>
              <a:ext cx="3013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99" name="Εικόνα 33880" descr=""/>
            <p:cNvPicPr/>
            <p:nvPr/>
          </p:nvPicPr>
          <p:blipFill>
            <a:blip r:embed="rId23"/>
            <a:stretch/>
          </p:blipFill>
          <p:spPr>
            <a:xfrm>
              <a:off x="8744040" y="11102760"/>
              <a:ext cx="2062080" cy="41371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0" name="Εικόνα 33882" descr=""/>
            <p:cNvPicPr/>
            <p:nvPr/>
          </p:nvPicPr>
          <p:blipFill>
            <a:blip r:embed="rId24"/>
            <a:stretch/>
          </p:blipFill>
          <p:spPr>
            <a:xfrm>
              <a:off x="11172960" y="11102760"/>
              <a:ext cx="2063520" cy="413712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101" name="42 - TextBox"/>
          <p:cNvSpPr/>
          <p:nvPr/>
        </p:nvSpPr>
        <p:spPr>
          <a:xfrm>
            <a:off x="6723000" y="1700280"/>
            <a:ext cx="733320" cy="396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2" name="Ομάδα 1"/>
          <p:cNvGrpSpPr/>
          <p:nvPr/>
        </p:nvGrpSpPr>
        <p:grpSpPr>
          <a:xfrm>
            <a:off x="2411280" y="1270080"/>
            <a:ext cx="8893440" cy="10501200"/>
            <a:chOff x="2411280" y="1270080"/>
            <a:chExt cx="8893440" cy="10501200"/>
          </a:xfrm>
        </p:grpSpPr>
        <p:pic>
          <p:nvPicPr>
            <p:cNvPr id="103" name="Εικόνα 3" descr=""/>
            <p:cNvPicPr/>
            <p:nvPr/>
          </p:nvPicPr>
          <p:blipFill>
            <a:blip r:embed="rId1"/>
            <a:stretch/>
          </p:blipFill>
          <p:spPr>
            <a:xfrm>
              <a:off x="5502960" y="1298520"/>
              <a:ext cx="2387880" cy="4768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4" name="Εικόνα 6" descr=""/>
            <p:cNvPicPr/>
            <p:nvPr/>
          </p:nvPicPr>
          <p:blipFill>
            <a:blip r:embed="rId2"/>
            <a:stretch/>
          </p:blipFill>
          <p:spPr>
            <a:xfrm>
              <a:off x="2418120" y="1270080"/>
              <a:ext cx="2405160" cy="47851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5" name="Εικόνα 8" descr=""/>
            <p:cNvPicPr/>
            <p:nvPr/>
          </p:nvPicPr>
          <p:blipFill>
            <a:blip r:embed="rId3"/>
            <a:stretch/>
          </p:blipFill>
          <p:spPr>
            <a:xfrm>
              <a:off x="8711280" y="1298520"/>
              <a:ext cx="2422440" cy="4768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6" name="Εικόνα 10" descr=""/>
            <p:cNvPicPr/>
            <p:nvPr/>
          </p:nvPicPr>
          <p:blipFill>
            <a:blip r:embed="rId4"/>
            <a:stretch/>
          </p:blipFill>
          <p:spPr>
            <a:xfrm>
              <a:off x="2411280" y="6884640"/>
              <a:ext cx="2373480" cy="4886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7" name="Εικόνα 12" descr=""/>
            <p:cNvPicPr/>
            <p:nvPr/>
          </p:nvPicPr>
          <p:blipFill>
            <a:blip r:embed="rId5"/>
            <a:stretch/>
          </p:blipFill>
          <p:spPr>
            <a:xfrm>
              <a:off x="5771160" y="6907320"/>
              <a:ext cx="2396520" cy="48639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8" name="Εικόνα 14" descr=""/>
            <p:cNvPicPr/>
            <p:nvPr/>
          </p:nvPicPr>
          <p:blipFill>
            <a:blip r:embed="rId6"/>
            <a:stretch/>
          </p:blipFill>
          <p:spPr>
            <a:xfrm>
              <a:off x="8888040" y="6912720"/>
              <a:ext cx="2416680" cy="485856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109" name="42 - TextBox"/>
          <p:cNvSpPr/>
          <p:nvPr/>
        </p:nvSpPr>
        <p:spPr>
          <a:xfrm>
            <a:off x="1660680" y="549360"/>
            <a:ext cx="733320" cy="396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0" name="42 - TextBox"/>
          <p:cNvSpPr/>
          <p:nvPr/>
        </p:nvSpPr>
        <p:spPr>
          <a:xfrm>
            <a:off x="1371600" y="509760"/>
            <a:ext cx="733320" cy="396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11" name="Ομάδα 28"/>
          <p:cNvGrpSpPr/>
          <p:nvPr/>
        </p:nvGrpSpPr>
        <p:grpSpPr>
          <a:xfrm>
            <a:off x="2192400" y="1008000"/>
            <a:ext cx="9331200" cy="12654000"/>
            <a:chOff x="2192400" y="1008000"/>
            <a:chExt cx="9331200" cy="12654000"/>
          </a:xfrm>
        </p:grpSpPr>
        <p:pic>
          <p:nvPicPr>
            <p:cNvPr id="112" name="Εικόνα 17" descr=""/>
            <p:cNvPicPr/>
            <p:nvPr/>
          </p:nvPicPr>
          <p:blipFill>
            <a:blip r:embed="rId1"/>
            <a:stretch/>
          </p:blipFill>
          <p:spPr>
            <a:xfrm>
              <a:off x="2192400" y="1008000"/>
              <a:ext cx="3018960" cy="58093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13" name="Εικόνα 19" descr=""/>
            <p:cNvPicPr/>
            <p:nvPr/>
          </p:nvPicPr>
          <p:blipFill>
            <a:blip r:embed="rId2"/>
            <a:stretch/>
          </p:blipFill>
          <p:spPr>
            <a:xfrm>
              <a:off x="5152320" y="1022040"/>
              <a:ext cx="3030480" cy="57952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14" name="Εικόνα 21" descr=""/>
            <p:cNvPicPr/>
            <p:nvPr/>
          </p:nvPicPr>
          <p:blipFill>
            <a:blip r:embed="rId3"/>
            <a:stretch/>
          </p:blipFill>
          <p:spPr>
            <a:xfrm>
              <a:off x="8391960" y="1008000"/>
              <a:ext cx="3024720" cy="58093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15" name="Εικόνα 23" descr=""/>
            <p:cNvPicPr/>
            <p:nvPr/>
          </p:nvPicPr>
          <p:blipFill>
            <a:blip r:embed="rId4"/>
            <a:stretch/>
          </p:blipFill>
          <p:spPr>
            <a:xfrm>
              <a:off x="5224680" y="7725600"/>
              <a:ext cx="2958120" cy="58968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16" name="Εικόνα 25" descr=""/>
            <p:cNvPicPr/>
            <p:nvPr/>
          </p:nvPicPr>
          <p:blipFill>
            <a:blip r:embed="rId5"/>
            <a:stretch/>
          </p:blipFill>
          <p:spPr>
            <a:xfrm>
              <a:off x="2237400" y="7725600"/>
              <a:ext cx="2986920" cy="5936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17" name="Εικόνα 27" descr=""/>
            <p:cNvPicPr/>
            <p:nvPr/>
          </p:nvPicPr>
          <p:blipFill>
            <a:blip r:embed="rId6"/>
            <a:stretch/>
          </p:blipFill>
          <p:spPr>
            <a:xfrm>
              <a:off x="8504640" y="7785000"/>
              <a:ext cx="3018960" cy="5877000"/>
            </a:xfrm>
            <a:prstGeom prst="rect">
              <a:avLst/>
            </a:prstGeom>
            <a:ln w="0">
              <a:noFill/>
            </a:ln>
          </p:spPr>
        </p:pic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804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0-11-29T11:22:21Z</dcterms:created>
  <dc:creator>Dell User</dc:creator>
  <dc:description/>
  <dc:language>en-US</dc:language>
  <cp:lastModifiedBy>Priya V.</cp:lastModifiedBy>
  <cp:lastPrinted>2023-01-20T17:09:44Z</cp:lastPrinted>
  <dcterms:modified xsi:type="dcterms:W3CDTF">2023-02-01T04:20:15Z</dcterms:modified>
  <cp:revision>364</cp:revision>
  <dc:subject/>
  <dc:title>PowerPoint Presentation</dc:title>
</cp:coreProperties>
</file>